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1" d="100"/>
          <a:sy n="51" d="100"/>
        </p:scale>
        <p:origin x="-2766" y="-12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991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906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237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366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176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145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28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112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069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26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2117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E8C00E-D553-44A6-BE05-D48587EA785B}" type="datetimeFigureOut">
              <a:rPr lang="en-US" smtClean="0"/>
              <a:t>6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A3E323-6595-4246-BBCE-93A538A2F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749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184963"/>
              </p:ext>
            </p:extLst>
          </p:nvPr>
        </p:nvGraphicFramePr>
        <p:xfrm>
          <a:off x="762000" y="1447800"/>
          <a:ext cx="8026398" cy="3975735"/>
        </p:xfrm>
        <a:graphic>
          <a:graphicData uri="http://schemas.openxmlformats.org/drawingml/2006/table">
            <a:tbl>
              <a:tblPr/>
              <a:tblGrid>
                <a:gridCol w="609841"/>
                <a:gridCol w="609841"/>
                <a:gridCol w="609841"/>
                <a:gridCol w="609841"/>
                <a:gridCol w="609841"/>
                <a:gridCol w="609841"/>
                <a:gridCol w="609841"/>
                <a:gridCol w="241395"/>
                <a:gridCol w="1257798"/>
                <a:gridCol w="505025"/>
                <a:gridCol w="533611"/>
                <a:gridCol w="609841"/>
                <a:gridCol w="609841"/>
              </a:tblGrid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200" b="1" i="0" u="sng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 spectrum cou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1" i="0" u="sng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1" i="0" u="sng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346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346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cession Numb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6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1.4 OS=Homo sapiens GN=HIST1H1E PE=1 SV=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14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6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1.5 OS=Homo sapiens GN=HIST1H1B PE=1 SV=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15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8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2B type 1-C/E/F/G/I OS=Homo sapiens GN=HIST1H2BC PE=1 SV=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2B1C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7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re histone macro-H2A.1 OS=Homo sapiens GN=H2AFY PE=1 SV=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2AY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6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1.2 OS=Homo sapiens GN=HIST1H1C PE=1 SV=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12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6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3.3 OS=Homo sapiens GN=H3F3A PE=1 SV=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33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6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1x OS=Homo sapiens GN=H1FX PE=1 SV=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1X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7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2A type 1-D OS=Homo sapiens GN=HIST1H2AD PE=1 SV=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2A1D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6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1.0 OS=Homo sapiens GN=H1F0 PE=1 SV=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10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6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1.3 OS=Homo sapiens GN=HIST1H1D PE=1 SV=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13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6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stone H4 OS=Homo sapiens GN=HIST1H4A PE=1 SV=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4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gridSpan="8"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re histone macro-H2A.2 OS=Homo sapiens GN=H2AFY2 PE=1 SV=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2AW_Hum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Total nuclea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6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Total cytoplasmi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28600" y="340958"/>
            <a:ext cx="86549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Table 1</a:t>
            </a:r>
            <a:r>
              <a:rPr lang="en-US" dirty="0" smtClean="0"/>
              <a:t>. Quantification of histones in </a:t>
            </a:r>
            <a:r>
              <a:rPr lang="en-US" dirty="0"/>
              <a:t>the nuclear and cytosolic preparations </a:t>
            </a:r>
            <a:endParaRPr lang="en-US" dirty="0" smtClean="0"/>
          </a:p>
          <a:p>
            <a:r>
              <a:rPr lang="en-US" dirty="0" smtClean="0"/>
              <a:t>based </a:t>
            </a:r>
            <a:r>
              <a:rPr lang="en-US" dirty="0"/>
              <a:t>on total spectral counts</a:t>
            </a:r>
            <a:r>
              <a:rPr lang="en-US" dirty="0" smtClean="0"/>
              <a:t> 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5333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74</Words>
  <Application>Microsoft Office PowerPoint</Application>
  <PresentationFormat>On-screen Show (4:3)</PresentationFormat>
  <Paragraphs>7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yne State University School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zinic, Sijana</dc:creator>
  <cp:lastModifiedBy>Dzinic, Sijana</cp:lastModifiedBy>
  <cp:revision>5</cp:revision>
  <dcterms:created xsi:type="dcterms:W3CDTF">2013-01-08T18:08:21Z</dcterms:created>
  <dcterms:modified xsi:type="dcterms:W3CDTF">2013-06-26T18:37:32Z</dcterms:modified>
</cp:coreProperties>
</file>